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82" d="100"/>
          <a:sy n="82" d="100"/>
        </p:scale>
        <p:origin x="-3276" y="-8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llah\Desktop\DO_de_SB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allah\Desktop\DO_de_SB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Bromophenol</a:t>
            </a:r>
            <a:r>
              <a:rPr lang="en-US" sz="1000" baseline="0" dirty="0" smtClean="0">
                <a:latin typeface="Times New Roman" pitchFamily="18" charset="0"/>
                <a:cs typeface="Times New Roman" pitchFamily="18" charset="0"/>
              </a:rPr>
              <a:t> blue d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iffusion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c:rich>
      </c:tx>
      <c:layout>
        <c:manualLayout>
          <c:xMode val="edge"/>
          <c:yMode val="edge"/>
          <c:x val="0.26842964279845233"/>
          <c:y val="5.8789764100285163E-2"/>
        </c:manualLayout>
      </c:layout>
      <c:overlay val="0"/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Feuil2!$A$7</c:f>
              <c:strCache>
                <c:ptCount val="1"/>
                <c:pt idx="0">
                  <c:v>Do </c:v>
                </c:pt>
              </c:strCache>
            </c:strRef>
          </c:tx>
          <c:xVal>
            <c:numRef>
              <c:f>Feuil2!$B$6:$L$6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25</c:v>
                </c:pt>
                <c:pt idx="10">
                  <c:v>30</c:v>
                </c:pt>
              </c:numCache>
            </c:numRef>
          </c:xVal>
          <c:yVal>
            <c:numRef>
              <c:f>Feuil2!$B$7:$L$7</c:f>
              <c:numCache>
                <c:formatCode>General</c:formatCode>
                <c:ptCount val="11"/>
                <c:pt idx="0">
                  <c:v>2.1333333333333385E-2</c:v>
                </c:pt>
                <c:pt idx="1">
                  <c:v>0.20433333333333367</c:v>
                </c:pt>
                <c:pt idx="2">
                  <c:v>0.2886666666666674</c:v>
                </c:pt>
                <c:pt idx="3">
                  <c:v>0.33300000000000074</c:v>
                </c:pt>
                <c:pt idx="4">
                  <c:v>0.37733333333333335</c:v>
                </c:pt>
                <c:pt idx="5">
                  <c:v>0.40766666666666723</c:v>
                </c:pt>
                <c:pt idx="6">
                  <c:v>0.42433333333333328</c:v>
                </c:pt>
                <c:pt idx="7">
                  <c:v>0.45033333333333325</c:v>
                </c:pt>
                <c:pt idx="8">
                  <c:v>0.46466666666666723</c:v>
                </c:pt>
                <c:pt idx="9">
                  <c:v>0.56866666666666654</c:v>
                </c:pt>
                <c:pt idx="10">
                  <c:v>0.5643333333333333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1123840"/>
        <c:axId val="41125760"/>
      </c:scatterChart>
      <c:valAx>
        <c:axId val="4112384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 smtClean="0"/>
                  <a:t>Time </a:t>
                </a:r>
                <a:r>
                  <a:rPr lang="en-US" dirty="0"/>
                  <a:t>(h)</a:t>
                </a: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crossAx val="41125760"/>
        <c:crosses val="autoZero"/>
        <c:crossBetween val="midCat"/>
      </c:valAx>
      <c:valAx>
        <c:axId val="41125760"/>
        <c:scaling>
          <c:orientation val="minMax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fr-FR" dirty="0" smtClean="0"/>
                  <a:t>A  </a:t>
                </a:r>
                <a:r>
                  <a:rPr lang="fr-FR" dirty="0"/>
                  <a:t>592nm</a:t>
                </a: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crossAx val="41123840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/>
            </a:pPr>
            <a:r>
              <a:rPr lang="fr-FR" sz="1000" b="1" dirty="0" smtClean="0"/>
              <a:t>Bile </a:t>
            </a:r>
            <a:r>
              <a:rPr lang="fr-FR" sz="1000" b="1" dirty="0" err="1" smtClean="0"/>
              <a:t>salts</a:t>
            </a:r>
            <a:r>
              <a:rPr lang="fr-FR" sz="1000" b="1" dirty="0" smtClean="0"/>
              <a:t> diffusion</a:t>
            </a:r>
            <a:endParaRPr lang="fr-FR" sz="1000" b="1" dirty="0"/>
          </a:p>
        </c:rich>
      </c:tx>
      <c:layout>
        <c:manualLayout>
          <c:xMode val="edge"/>
          <c:yMode val="edge"/>
          <c:x val="0.3407834782143595"/>
          <c:y val="9.9942598970484783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0758441346744094"/>
          <c:y val="0.20263489241936097"/>
          <c:w val="0.7152985958468856"/>
          <c:h val="0.5460189608561995"/>
        </c:manualLayout>
      </c:layout>
      <c:lineChart>
        <c:grouping val="standard"/>
        <c:varyColors val="0"/>
        <c:ser>
          <c:idx val="1"/>
          <c:order val="0"/>
          <c:tx>
            <c:strRef>
              <c:f>Feuil1!$C$2</c:f>
              <c:strCache>
                <c:ptCount val="1"/>
                <c:pt idx="0">
                  <c:v>Sel biliaire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Feuil1!$C$6:$J$6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</c:v>
                  </c:pt>
                  <c:pt idx="2">
                    <c:v>3.262940605255623E-2</c:v>
                  </c:pt>
                  <c:pt idx="3">
                    <c:v>4.9896323772894713E-2</c:v>
                  </c:pt>
                  <c:pt idx="4">
                    <c:v>4.4555970147697813E-2</c:v>
                  </c:pt>
                  <c:pt idx="5">
                    <c:v>4.5020709588497965E-2</c:v>
                  </c:pt>
                  <c:pt idx="6">
                    <c:v>0.14533312205599624</c:v>
                  </c:pt>
                  <c:pt idx="7">
                    <c:v>0.14413114837947141</c:v>
                  </c:pt>
                </c:numCache>
              </c:numRef>
            </c:plus>
            <c:minus>
              <c:numRef>
                <c:f>Feuil1!$C$6:$J$6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</c:v>
                  </c:pt>
                  <c:pt idx="2">
                    <c:v>3.262940605255623E-2</c:v>
                  </c:pt>
                  <c:pt idx="3">
                    <c:v>4.9896323772894713E-2</c:v>
                  </c:pt>
                  <c:pt idx="4">
                    <c:v>4.4555970147697813E-2</c:v>
                  </c:pt>
                  <c:pt idx="5">
                    <c:v>4.5020709588497965E-2</c:v>
                  </c:pt>
                  <c:pt idx="6">
                    <c:v>0.14533312205599624</c:v>
                  </c:pt>
                  <c:pt idx="7">
                    <c:v>0.14413114837947141</c:v>
                  </c:pt>
                </c:numCache>
              </c:numRef>
            </c:minus>
          </c:errBars>
          <c:cat>
            <c:numRef>
              <c:f>Feuil1!$D$1:$N$1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25</c:v>
                </c:pt>
                <c:pt idx="10">
                  <c:v>30</c:v>
                </c:pt>
              </c:numCache>
            </c:numRef>
          </c:cat>
          <c:val>
            <c:numRef>
              <c:f>Feuil1!$B$11:$H$11</c:f>
              <c:numCache>
                <c:formatCode>General</c:formatCode>
                <c:ptCount val="7"/>
                <c:pt idx="0">
                  <c:v>0</c:v>
                </c:pt>
                <c:pt idx="1">
                  <c:v>0.19213055444444438</c:v>
                </c:pt>
                <c:pt idx="2">
                  <c:v>0.38455554555555582</c:v>
                </c:pt>
                <c:pt idx="3">
                  <c:v>0.73088888666666663</c:v>
                </c:pt>
                <c:pt idx="4">
                  <c:v>0.92577777888889123</c:v>
                </c:pt>
                <c:pt idx="5">
                  <c:v>1.2992222233333333</c:v>
                </c:pt>
                <c:pt idx="6">
                  <c:v>1.302466668888889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1532416"/>
        <c:axId val="42926848"/>
      </c:lineChart>
      <c:catAx>
        <c:axId val="415324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crossAx val="42926848"/>
        <c:crosses val="autoZero"/>
        <c:auto val="1"/>
        <c:lblAlgn val="ctr"/>
        <c:lblOffset val="100"/>
        <c:noMultiLvlLbl val="0"/>
      </c:catAx>
      <c:valAx>
        <c:axId val="42926848"/>
        <c:scaling>
          <c:orientation val="minMax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en-US" sz="1000" baseline="0" dirty="0" smtClean="0"/>
                  <a:t>A </a:t>
                </a:r>
                <a:r>
                  <a:rPr lang="en-US" sz="1000" baseline="0" dirty="0"/>
                  <a:t>201nm</a:t>
                </a:r>
                <a:endParaRPr lang="en-US" sz="1000" dirty="0"/>
              </a:p>
            </c:rich>
          </c:tx>
          <c:layout>
            <c:manualLayout>
              <c:xMode val="edge"/>
              <c:yMode val="edge"/>
              <c:x val="0"/>
              <c:y val="0.31434534669791531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crossAx val="4153241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5249</cdr:x>
      <cdr:y>0.84375</cdr:y>
    </cdr:from>
    <cdr:to>
      <cdr:x>0.75654</cdr:x>
      <cdr:y>0.96667</cdr:y>
    </cdr:to>
    <cdr:sp macro="" textlink="">
      <cdr:nvSpPr>
        <cdr:cNvPr id="2" name="ZoneTexte 1"/>
        <cdr:cNvSpPr txBox="1"/>
      </cdr:nvSpPr>
      <cdr:spPr>
        <a:xfrm xmlns:a="http://schemas.openxmlformats.org/drawingml/2006/main">
          <a:off x="1421257" y="1822703"/>
          <a:ext cx="955007" cy="26552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fr-FR" sz="1000" b="1" dirty="0" smtClean="0"/>
            <a:t>Time </a:t>
          </a:r>
          <a:r>
            <a:rPr lang="fr-FR" sz="1000" b="1" dirty="0"/>
            <a:t>(h)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FAA8-98D9-4FE4-9DAE-5CD6104F4327}" type="datetimeFigureOut">
              <a:rPr lang="fr-FR" smtClean="0"/>
              <a:t>25/10/201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7CF6B-428D-47BC-89BC-3AFC69905D8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943767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FAA8-98D9-4FE4-9DAE-5CD6104F4327}" type="datetimeFigureOut">
              <a:rPr lang="fr-FR" smtClean="0"/>
              <a:t>25/10/201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7CF6B-428D-47BC-89BC-3AFC69905D8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526764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FAA8-98D9-4FE4-9DAE-5CD6104F4327}" type="datetimeFigureOut">
              <a:rPr lang="fr-FR" smtClean="0"/>
              <a:t>25/10/201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7CF6B-428D-47BC-89BC-3AFC69905D8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199029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FAA8-98D9-4FE4-9DAE-5CD6104F4327}" type="datetimeFigureOut">
              <a:rPr lang="fr-FR" smtClean="0"/>
              <a:t>25/10/201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7CF6B-428D-47BC-89BC-3AFC69905D8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331603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FAA8-98D9-4FE4-9DAE-5CD6104F4327}" type="datetimeFigureOut">
              <a:rPr lang="fr-FR" smtClean="0"/>
              <a:t>25/10/201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7CF6B-428D-47BC-89BC-3AFC69905D8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184038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FAA8-98D9-4FE4-9DAE-5CD6104F4327}" type="datetimeFigureOut">
              <a:rPr lang="fr-FR" smtClean="0"/>
              <a:t>25/10/201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7CF6B-428D-47BC-89BC-3AFC69905D8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366391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FAA8-98D9-4FE4-9DAE-5CD6104F4327}" type="datetimeFigureOut">
              <a:rPr lang="fr-FR" smtClean="0"/>
              <a:t>25/10/201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7CF6B-428D-47BC-89BC-3AFC69905D8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97419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FAA8-98D9-4FE4-9DAE-5CD6104F4327}" type="datetimeFigureOut">
              <a:rPr lang="fr-FR" smtClean="0"/>
              <a:t>25/10/201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7CF6B-428D-47BC-89BC-3AFC69905D8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617635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FAA8-98D9-4FE4-9DAE-5CD6104F4327}" type="datetimeFigureOut">
              <a:rPr lang="fr-FR" smtClean="0"/>
              <a:t>25/10/201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7CF6B-428D-47BC-89BC-3AFC69905D8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656838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FAA8-98D9-4FE4-9DAE-5CD6104F4327}" type="datetimeFigureOut">
              <a:rPr lang="fr-FR" smtClean="0"/>
              <a:t>25/10/201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7CF6B-428D-47BC-89BC-3AFC69905D8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314824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FAA8-98D9-4FE4-9DAE-5CD6104F4327}" type="datetimeFigureOut">
              <a:rPr lang="fr-FR" smtClean="0"/>
              <a:t>25/10/201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7CF6B-428D-47BC-89BC-3AFC69905D8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124638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D0FAA8-98D9-4FE4-9DAE-5CD6104F4327}" type="datetimeFigureOut">
              <a:rPr lang="fr-FR" smtClean="0"/>
              <a:t>25/10/201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F7CF6B-428D-47BC-89BC-3AFC69905D8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712493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7" Type="http://schemas.openxmlformats.org/officeDocument/2006/relationships/image" Target="../media/image4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jpeg"/><Relationship Id="rId5" Type="http://schemas.openxmlformats.org/officeDocument/2006/relationships/chart" Target="../charts/chart2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" name="Graphique 13"/>
          <p:cNvGraphicFramePr/>
          <p:nvPr>
            <p:extLst>
              <p:ext uri="{D42A27DB-BD31-4B8C-83A1-F6EECF244321}">
                <p14:modId xmlns:p14="http://schemas.microsoft.com/office/powerpoint/2010/main" val="182338913"/>
              </p:ext>
            </p:extLst>
          </p:nvPr>
        </p:nvGraphicFramePr>
        <p:xfrm>
          <a:off x="3586381" y="2748625"/>
          <a:ext cx="3286635" cy="23762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4" name="Groupe 3"/>
          <p:cNvGrpSpPr/>
          <p:nvPr/>
        </p:nvGrpSpPr>
        <p:grpSpPr>
          <a:xfrm>
            <a:off x="511112" y="660392"/>
            <a:ext cx="3434924" cy="2237861"/>
            <a:chOff x="179512" y="1182839"/>
            <a:chExt cx="5070049" cy="1958129"/>
          </a:xfrm>
        </p:grpSpPr>
        <p:pic>
          <p:nvPicPr>
            <p:cNvPr id="32" name="Image 31" descr="IMG00746-20110420-1717.jpg"/>
            <p:cNvPicPr>
              <a:picLocks noChangeAspect="1"/>
            </p:cNvPicPr>
            <p:nvPr/>
          </p:nvPicPr>
          <p:blipFill>
            <a:blip r:embed="rId3" cstate="print"/>
            <a:srcRect t="20516" b="35521"/>
            <a:stretch>
              <a:fillRect/>
            </a:stretch>
          </p:blipFill>
          <p:spPr>
            <a:xfrm>
              <a:off x="179512" y="1700808"/>
              <a:ext cx="4623439" cy="1440160"/>
            </a:xfrm>
            <a:prstGeom prst="rect">
              <a:avLst/>
            </a:prstGeom>
            <a:solidFill>
              <a:srgbClr val="FFFFFF">
                <a:shade val="85000"/>
              </a:srgbClr>
            </a:solidFill>
            <a:ln w="101600" cap="sq">
              <a:solidFill>
                <a:srgbClr val="FDFDFD"/>
              </a:solidFill>
              <a:miter lim="800000"/>
            </a:ln>
            <a:effectLst>
              <a:outerShdw blurRad="57150" dist="37500" dir="7560000" sy="98000" kx="110000" ky="200000" algn="tl" rotWithShape="0">
                <a:srgbClr val="000000">
                  <a:alpha val="20000"/>
                </a:srgbClr>
              </a:outerShdw>
            </a:effectLst>
            <a:scene3d>
              <a:camera prst="perspectiveRelaxed">
                <a:rot lat="18960000" lon="0" rev="0"/>
              </a:camera>
              <a:lightRig rig="twoPt" dir="t">
                <a:rot lat="0" lon="0" rev="7200000"/>
              </a:lightRig>
            </a:scene3d>
            <a:sp3d prstMaterial="matte">
              <a:bevelT w="22860" h="12700"/>
              <a:contourClr>
                <a:srgbClr val="FFFFFF"/>
              </a:contourClr>
            </a:sp3d>
          </p:spPr>
        </p:pic>
        <p:cxnSp>
          <p:nvCxnSpPr>
            <p:cNvPr id="33" name="Connecteur droit avec flèche 32"/>
            <p:cNvCxnSpPr/>
            <p:nvPr/>
          </p:nvCxnSpPr>
          <p:spPr>
            <a:xfrm rot="5400000">
              <a:off x="4123121" y="1928040"/>
              <a:ext cx="936104" cy="158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Connecteur droit avec flèche 33"/>
            <p:cNvCxnSpPr/>
            <p:nvPr/>
          </p:nvCxnSpPr>
          <p:spPr>
            <a:xfrm rot="5400000">
              <a:off x="2944544" y="1964044"/>
              <a:ext cx="1008112" cy="1587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Connecteur droit avec flèche 34"/>
            <p:cNvCxnSpPr/>
            <p:nvPr/>
          </p:nvCxnSpPr>
          <p:spPr>
            <a:xfrm rot="5400000">
              <a:off x="1242124" y="1952864"/>
              <a:ext cx="553970" cy="22036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ZoneTexte 14"/>
            <p:cNvSpPr txBox="1"/>
            <p:nvPr/>
          </p:nvSpPr>
          <p:spPr>
            <a:xfrm>
              <a:off x="4058950" y="1218408"/>
              <a:ext cx="1190611" cy="242374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atheter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ZoneTexte 15"/>
            <p:cNvSpPr txBox="1"/>
            <p:nvPr/>
          </p:nvSpPr>
          <p:spPr>
            <a:xfrm>
              <a:off x="2723957" y="1281415"/>
              <a:ext cx="1334993" cy="242374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utures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ZoneTexte 16"/>
            <p:cNvSpPr txBox="1"/>
            <p:nvPr/>
          </p:nvSpPr>
          <p:spPr>
            <a:xfrm>
              <a:off x="437237" y="1182839"/>
              <a:ext cx="2035002" cy="40395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ialysis tubing </a:t>
              </a:r>
            </a:p>
            <a:p>
              <a:pPr algn="ctr"/>
              <a:r>
                <a:rPr lang="en-GB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 cut off 50kDA)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" name="Groupe 4"/>
          <p:cNvGrpSpPr/>
          <p:nvPr/>
        </p:nvGrpSpPr>
        <p:grpSpPr>
          <a:xfrm>
            <a:off x="4356659" y="710888"/>
            <a:ext cx="2721758" cy="1749705"/>
            <a:chOff x="4415301" y="1022095"/>
            <a:chExt cx="2721758" cy="1749705"/>
          </a:xfrm>
        </p:grpSpPr>
        <p:sp>
          <p:nvSpPr>
            <p:cNvPr id="27" name="ZoneTexte 27"/>
            <p:cNvSpPr txBox="1"/>
            <p:nvPr/>
          </p:nvSpPr>
          <p:spPr>
            <a:xfrm>
              <a:off x="5872019" y="2204282"/>
              <a:ext cx="1196752" cy="276999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extran Blue</a:t>
              </a:r>
            </a:p>
          </p:txBody>
        </p:sp>
        <p:pic>
          <p:nvPicPr>
            <p:cNvPr id="28" name="Image 27"/>
            <p:cNvPicPr/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 rot="16200000">
              <a:off x="4127418" y="1309978"/>
              <a:ext cx="1749705" cy="11739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29" name="Connecteur droit avec flèche 28"/>
            <p:cNvCxnSpPr/>
            <p:nvPr/>
          </p:nvCxnSpPr>
          <p:spPr>
            <a:xfrm rot="10800000">
              <a:off x="5229200" y="1907704"/>
              <a:ext cx="581074" cy="1823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Connecteur droit avec flèche 29"/>
            <p:cNvCxnSpPr/>
            <p:nvPr/>
          </p:nvCxnSpPr>
          <p:spPr>
            <a:xfrm rot="10800000" flipV="1">
              <a:off x="5348354" y="2339751"/>
              <a:ext cx="635641" cy="1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ZoneTexte 26"/>
            <p:cNvSpPr txBox="1"/>
            <p:nvPr/>
          </p:nvSpPr>
          <p:spPr>
            <a:xfrm>
              <a:off x="5755408" y="1763688"/>
              <a:ext cx="1381651" cy="276999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istilled water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" name="ZoneTexte 28"/>
          <p:cNvSpPr txBox="1"/>
          <p:nvPr/>
        </p:nvSpPr>
        <p:spPr>
          <a:xfrm>
            <a:off x="-31733" y="579093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ZoneTexte 29"/>
          <p:cNvSpPr txBox="1"/>
          <p:nvPr/>
        </p:nvSpPr>
        <p:spPr>
          <a:xfrm>
            <a:off x="3919690" y="588385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ZoneTexte 30"/>
          <p:cNvSpPr txBox="1"/>
          <p:nvPr/>
        </p:nvSpPr>
        <p:spPr>
          <a:xfrm>
            <a:off x="418030" y="2883349"/>
            <a:ext cx="6926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ectangle 8"/>
          <p:cNvSpPr>
            <a:spLocks noChangeArrowheads="1"/>
          </p:cNvSpPr>
          <p:nvPr/>
        </p:nvSpPr>
        <p:spPr bwMode="auto">
          <a:xfrm>
            <a:off x="274014" y="7590679"/>
            <a:ext cx="6264696" cy="229293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sz="11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Supplemental Figure</a:t>
            </a:r>
            <a:r>
              <a:rPr lang="en-GB" sz="1100" b="1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 </a:t>
            </a:r>
            <a:r>
              <a:rPr lang="en-GB" sz="1100" b="1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A</a:t>
            </a:r>
            <a:r>
              <a:rPr lang="en-GB" sz="1100" b="1" smtClean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1</a:t>
            </a:r>
            <a:r>
              <a:rPr kumimoji="0" lang="en-GB" sz="11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: </a:t>
            </a:r>
            <a:r>
              <a:rPr lang="en-GB" sz="1100" dirty="0" smtClean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Dialysis device allowing development of the bacterial implant. </a:t>
            </a:r>
          </a:p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Calibri" pitchFamily="34" charset="0"/>
              <a:cs typeface="Arial" panose="020B0604020202020204" pitchFamily="34" charset="0"/>
            </a:endParaRPr>
          </a:p>
          <a:p>
            <a:pPr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sz="1100" dirty="0" smtClean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A : The dialysis tubing (cut off 50 </a:t>
            </a:r>
            <a:r>
              <a:rPr lang="en-GB" sz="1100" dirty="0" err="1" smtClean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kDa</a:t>
            </a:r>
            <a:r>
              <a:rPr lang="en-GB" sz="1100" dirty="0" smtClean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), sealed at one end, was fasten to a surgical catheter and the tightness achieved using sutures with surgical thread. This device allows diffusion of molecules below 50 </a:t>
            </a:r>
            <a:r>
              <a:rPr lang="en-GB" sz="1100" dirty="0" err="1" smtClean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kDa</a:t>
            </a:r>
            <a:r>
              <a:rPr lang="en-GB" sz="1100" dirty="0" smtClean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 while retaining molecules above 50 </a:t>
            </a:r>
            <a:r>
              <a:rPr lang="en-GB" sz="1100" dirty="0" err="1" smtClean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kDa</a:t>
            </a:r>
            <a:r>
              <a:rPr lang="en-GB" sz="1100" dirty="0" smtClean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.</a:t>
            </a:r>
          </a:p>
          <a:p>
            <a:pPr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GB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B : Checking</a:t>
            </a:r>
            <a:r>
              <a:rPr kumimoji="0" lang="en-GB" sz="11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 </a:t>
            </a:r>
            <a:r>
              <a:rPr kumimoji="0" lang="en-GB" sz="1100" b="0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impermeability</a:t>
            </a:r>
            <a:r>
              <a:rPr kumimoji="0" lang="en-GB" sz="11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 of the implant towards Dextran Blue (MW 100 </a:t>
            </a:r>
            <a:r>
              <a:rPr kumimoji="0" lang="en-GB" sz="1100" b="0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kDa</a:t>
            </a:r>
            <a:r>
              <a:rPr kumimoji="0" lang="en-GB" sz="11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). Ten mL of a 1% solution were placed in the implant and dialyzed against 24 h against 1 L of distilled water. No blue staining of the distilled water was observed, whatever the dialysis time.</a:t>
            </a:r>
          </a:p>
          <a:p>
            <a:pPr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sz="1100" dirty="0" smtClean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C : Checking permeability of the implant towards Bromophenol Blue (same protocol). The blue staining diffuses into the distilled water, as evidenced by an increase in absorbance at 592 nm (D).</a:t>
            </a:r>
          </a:p>
          <a:p>
            <a:pPr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GB" sz="11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D : Checking entry of bile salts into the implant. Ten mL of distilled water wer</a:t>
            </a:r>
            <a:r>
              <a:rPr lang="en-GB" sz="1100" dirty="0" smtClean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e placed in the implant and dialyzed against 1 L of a 1 g/L bile salts solution. Diffusion of bile salts is monitored by following absorbance at 201 nm of the implant content.</a:t>
            </a:r>
            <a:endParaRPr kumimoji="0" lang="en-GB" sz="1100" b="0" i="0" u="none" strike="noStrike" cap="none" normalizeH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Calibri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0" name="Graphique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33482891"/>
              </p:ext>
            </p:extLst>
          </p:nvPr>
        </p:nvGraphicFramePr>
        <p:xfrm>
          <a:off x="3586382" y="5187377"/>
          <a:ext cx="3384376" cy="21602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1" name="ZoneTexte 23"/>
          <p:cNvSpPr txBox="1"/>
          <p:nvPr/>
        </p:nvSpPr>
        <p:spPr>
          <a:xfrm>
            <a:off x="3487324" y="2877199"/>
            <a:ext cx="648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" name="Groupe 12"/>
          <p:cNvGrpSpPr/>
          <p:nvPr/>
        </p:nvGrpSpPr>
        <p:grpSpPr>
          <a:xfrm>
            <a:off x="-90312" y="2964649"/>
            <a:ext cx="2857224" cy="4032448"/>
            <a:chOff x="-508342" y="2699792"/>
            <a:chExt cx="2857224" cy="4032448"/>
          </a:xfrm>
        </p:grpSpPr>
        <p:sp>
          <p:nvSpPr>
            <p:cNvPr id="15" name="ZoneTexte 45"/>
            <p:cNvSpPr txBox="1"/>
            <p:nvPr/>
          </p:nvSpPr>
          <p:spPr>
            <a:xfrm>
              <a:off x="-508342" y="3703630"/>
              <a:ext cx="1614783" cy="276999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romophenol blue</a:t>
              </a:r>
            </a:p>
          </p:txBody>
        </p:sp>
        <p:pic>
          <p:nvPicPr>
            <p:cNvPr id="17" name="Image 16" descr="IMG00394-20110119-1810.jpg"/>
            <p:cNvPicPr/>
            <p:nvPr/>
          </p:nvPicPr>
          <p:blipFill>
            <a:blip r:embed="rId6" cstate="print"/>
            <a:stretch>
              <a:fillRect/>
            </a:stretch>
          </p:blipFill>
          <p:spPr>
            <a:xfrm rot="16200000">
              <a:off x="980728" y="2915818"/>
              <a:ext cx="1584177" cy="1152126"/>
            </a:xfrm>
            <a:prstGeom prst="rect">
              <a:avLst/>
            </a:prstGeom>
          </p:spPr>
        </p:pic>
        <p:pic>
          <p:nvPicPr>
            <p:cNvPr id="18" name="Image 17"/>
            <p:cNvPicPr/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 rot="16200000">
              <a:off x="1052737" y="5436094"/>
              <a:ext cx="1512170" cy="10801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19" name="Connecteur droit avec flèche 18"/>
            <p:cNvCxnSpPr/>
            <p:nvPr/>
          </p:nvCxnSpPr>
          <p:spPr>
            <a:xfrm rot="5400000">
              <a:off x="1449574" y="4752020"/>
              <a:ext cx="647278" cy="794"/>
            </a:xfrm>
            <a:prstGeom prst="straightConnector1">
              <a:avLst/>
            </a:prstGeom>
            <a:ln w="38100" cmpd="sng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ZoneTexte 38"/>
            <p:cNvSpPr txBox="1"/>
            <p:nvPr/>
          </p:nvSpPr>
          <p:spPr>
            <a:xfrm>
              <a:off x="-271274" y="3203848"/>
              <a:ext cx="1356793" cy="276999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istilled water</a:t>
              </a:r>
            </a:p>
          </p:txBody>
        </p:sp>
        <p:sp>
          <p:nvSpPr>
            <p:cNvPr id="21" name="ZoneTexte 39"/>
            <p:cNvSpPr txBox="1"/>
            <p:nvPr/>
          </p:nvSpPr>
          <p:spPr>
            <a:xfrm>
              <a:off x="-271274" y="5796133"/>
              <a:ext cx="1396018" cy="276999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istilled water</a:t>
              </a:r>
            </a:p>
          </p:txBody>
        </p:sp>
        <p:cxnSp>
          <p:nvCxnSpPr>
            <p:cNvPr id="22" name="Connecteur droit avec flèche 21"/>
            <p:cNvCxnSpPr/>
            <p:nvPr/>
          </p:nvCxnSpPr>
          <p:spPr>
            <a:xfrm>
              <a:off x="1124744" y="5940149"/>
              <a:ext cx="648072" cy="158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Connecteur droit avec flèche 22"/>
            <p:cNvCxnSpPr/>
            <p:nvPr/>
          </p:nvCxnSpPr>
          <p:spPr>
            <a:xfrm>
              <a:off x="980728" y="3347864"/>
              <a:ext cx="648072" cy="158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Connecteur droit avec flèche 23"/>
            <p:cNvCxnSpPr/>
            <p:nvPr/>
          </p:nvCxnSpPr>
          <p:spPr>
            <a:xfrm>
              <a:off x="980728" y="3851920"/>
              <a:ext cx="576064" cy="158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Connecteur droit avec flèche 24"/>
            <p:cNvCxnSpPr/>
            <p:nvPr/>
          </p:nvCxnSpPr>
          <p:spPr>
            <a:xfrm>
              <a:off x="1052736" y="6442617"/>
              <a:ext cx="648072" cy="158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ZoneTexte 48"/>
            <p:cNvSpPr txBox="1"/>
            <p:nvPr/>
          </p:nvSpPr>
          <p:spPr>
            <a:xfrm rot="5400000">
              <a:off x="1607132" y="4607231"/>
              <a:ext cx="8963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iffusion 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9" name="ZoneTexte 45"/>
          <p:cNvSpPr txBox="1"/>
          <p:nvPr/>
        </p:nvSpPr>
        <p:spPr>
          <a:xfrm>
            <a:off x="-56445" y="6558332"/>
            <a:ext cx="1626072" cy="276999"/>
          </a:xfrm>
          <a:prstGeom prst="rect">
            <a:avLst/>
          </a:prstGeom>
          <a:noFill/>
          <a:ln>
            <a:noFill/>
          </a:ln>
          <a:effectLst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romophenol blue</a:t>
            </a:r>
          </a:p>
        </p:txBody>
      </p:sp>
      <p:sp>
        <p:nvSpPr>
          <p:cNvPr id="2" name="Rectangle 1"/>
          <p:cNvSpPr/>
          <p:nvPr/>
        </p:nvSpPr>
        <p:spPr>
          <a:xfrm>
            <a:off x="0" y="393539"/>
            <a:ext cx="3946036" cy="248366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" name="Rectangle 2"/>
          <p:cNvSpPr/>
          <p:nvPr/>
        </p:nvSpPr>
        <p:spPr>
          <a:xfrm>
            <a:off x="3946036" y="393539"/>
            <a:ext cx="2911964" cy="248366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6" name="Rectangle 15"/>
          <p:cNvSpPr/>
          <p:nvPr/>
        </p:nvSpPr>
        <p:spPr>
          <a:xfrm>
            <a:off x="0" y="2886678"/>
            <a:ext cx="3487324" cy="456741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1" name="Rectangle 40"/>
          <p:cNvSpPr/>
          <p:nvPr/>
        </p:nvSpPr>
        <p:spPr>
          <a:xfrm>
            <a:off x="3487324" y="2877199"/>
            <a:ext cx="3370676" cy="45768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4603726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8</TotalTime>
  <Words>254</Words>
  <Application>Microsoft Office PowerPoint</Application>
  <PresentationFormat>Format A4 (210 x 297 mm)</PresentationFormat>
  <Paragraphs>27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Jan</dc:creator>
  <cp:lastModifiedBy>Helene</cp:lastModifiedBy>
  <cp:revision>10</cp:revision>
  <dcterms:created xsi:type="dcterms:W3CDTF">2013-05-23T09:24:54Z</dcterms:created>
  <dcterms:modified xsi:type="dcterms:W3CDTF">2013-10-25T07:26:10Z</dcterms:modified>
</cp:coreProperties>
</file>